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E6A5B-B12D-479C-BB1D-7E61DFE8E2C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32C13-4E84-4770-8D73-E0DA4BE1A0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60075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E6A5B-B12D-479C-BB1D-7E61DFE8E2C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32C13-4E84-4770-8D73-E0DA4BE1A0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8254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E6A5B-B12D-479C-BB1D-7E61DFE8E2C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32C13-4E84-4770-8D73-E0DA4BE1A0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4187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E6A5B-B12D-479C-BB1D-7E61DFE8E2C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32C13-4E84-4770-8D73-E0DA4BE1A0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19555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E6A5B-B12D-479C-BB1D-7E61DFE8E2C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32C13-4E84-4770-8D73-E0DA4BE1A0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5519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E6A5B-B12D-479C-BB1D-7E61DFE8E2C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32C13-4E84-4770-8D73-E0DA4BE1A0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5379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E6A5B-B12D-479C-BB1D-7E61DFE8E2C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32C13-4E84-4770-8D73-E0DA4BE1A0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5188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E6A5B-B12D-479C-BB1D-7E61DFE8E2C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32C13-4E84-4770-8D73-E0DA4BE1A0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3459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E6A5B-B12D-479C-BB1D-7E61DFE8E2C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32C13-4E84-4770-8D73-E0DA4BE1A0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8682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E6A5B-B12D-479C-BB1D-7E61DFE8E2C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32C13-4E84-4770-8D73-E0DA4BE1A0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45882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E6A5B-B12D-479C-BB1D-7E61DFE8E2C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932C13-4E84-4770-8D73-E0DA4BE1A0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3244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E6A5B-B12D-479C-BB1D-7E61DFE8E2C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932C13-4E84-4770-8D73-E0DA4BE1A0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6477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3542" y="3752019"/>
            <a:ext cx="2985246" cy="8062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66" t="38681" r="40793" b="51168"/>
          <a:stretch/>
        </p:blipFill>
        <p:spPr>
          <a:xfrm>
            <a:off x="2783542" y="3039039"/>
            <a:ext cx="2985246" cy="63201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/>
          <p:cNvSpPr txBox="1"/>
          <p:nvPr/>
        </p:nvSpPr>
        <p:spPr>
          <a:xfrm>
            <a:off x="2049422" y="2684659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046188" y="266927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628892" y="266927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218795" y="2283588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589433" y="2266494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2" name="直接连接符 11"/>
          <p:cNvCxnSpPr/>
          <p:nvPr/>
        </p:nvCxnSpPr>
        <p:spPr>
          <a:xfrm>
            <a:off x="3140317" y="2631942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4718099" y="268720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300803" y="268720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4758440" y="2649872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5768788" y="3170379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GRB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813612" y="3941341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832271" y="1837831"/>
            <a:ext cx="294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STS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74307" y="512007"/>
            <a:ext cx="3339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3h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099486" y="4024851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2625592" y="4194128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2184651" y="3262855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5" name="直接连接符 24"/>
          <p:cNvCxnSpPr/>
          <p:nvPr/>
        </p:nvCxnSpPr>
        <p:spPr>
          <a:xfrm>
            <a:off x="2603181" y="3432132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34431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74307" y="512007"/>
            <a:ext cx="3339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3h.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76" t="26217" r="50304" b="62047"/>
          <a:stretch/>
        </p:blipFill>
        <p:spPr>
          <a:xfrm>
            <a:off x="2662516" y="4047563"/>
            <a:ext cx="1385049" cy="8264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28" t="20901" r="54952" b="68296"/>
          <a:stretch/>
        </p:blipFill>
        <p:spPr>
          <a:xfrm>
            <a:off x="4117039" y="4047563"/>
            <a:ext cx="1385049" cy="8264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4"/>
          <a:srcRect t="24897" r="4126" b="24298"/>
          <a:stretch/>
        </p:blipFill>
        <p:spPr>
          <a:xfrm>
            <a:off x="4117039" y="3372681"/>
            <a:ext cx="1385049" cy="6185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11"/>
          <p:cNvSpPr txBox="1"/>
          <p:nvPr/>
        </p:nvSpPr>
        <p:spPr>
          <a:xfrm>
            <a:off x="5571562" y="4326364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 (Input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502088" y="3513286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GRB2 (Pull-down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689750" y="1016539"/>
            <a:ext cx="294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STS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477808" y="3569600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9" name="直接连接符 18"/>
          <p:cNvCxnSpPr/>
          <p:nvPr/>
        </p:nvCxnSpPr>
        <p:spPr>
          <a:xfrm>
            <a:off x="3909785" y="3738877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1956050" y="4365514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1" name="直接连接符 20"/>
          <p:cNvCxnSpPr/>
          <p:nvPr/>
        </p:nvCxnSpPr>
        <p:spPr>
          <a:xfrm>
            <a:off x="2482156" y="4534791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1861164" y="2967046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857930" y="295165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3561657" y="295165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3030537" y="2565975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347387" y="2548881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7" name="直接连接符 26"/>
          <p:cNvCxnSpPr/>
          <p:nvPr/>
        </p:nvCxnSpPr>
        <p:spPr>
          <a:xfrm>
            <a:off x="2952059" y="2914329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4355030" y="296958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4991522" y="296958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4435712" y="2932259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297707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74307" y="512007"/>
            <a:ext cx="3339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3h.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09" t="46267" r="46544" b="43682"/>
          <a:stretch/>
        </p:blipFill>
        <p:spPr>
          <a:xfrm>
            <a:off x="2353235" y="3854766"/>
            <a:ext cx="2542085" cy="7395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/>
          <p:cNvSpPr txBox="1"/>
          <p:nvPr/>
        </p:nvSpPr>
        <p:spPr>
          <a:xfrm>
            <a:off x="1484648" y="2684659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481414" y="266927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064118" y="266927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654021" y="2283588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701931" y="2266494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0" name="直接连接符 9"/>
          <p:cNvCxnSpPr/>
          <p:nvPr/>
        </p:nvCxnSpPr>
        <p:spPr>
          <a:xfrm>
            <a:off x="2575543" y="2631942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3830597" y="268720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413301" y="268720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3" name="直接连接符 12"/>
          <p:cNvCxnSpPr/>
          <p:nvPr/>
        </p:nvCxnSpPr>
        <p:spPr>
          <a:xfrm>
            <a:off x="3870938" y="2649872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4988862" y="3170379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GRB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015340" y="4057832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267497" y="1837831"/>
            <a:ext cx="294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STS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53235" y="3099638"/>
            <a:ext cx="2560432" cy="694952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6170613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203"/>
          <a:stretch/>
        </p:blipFill>
        <p:spPr>
          <a:xfrm>
            <a:off x="2326340" y="2165335"/>
            <a:ext cx="4837838" cy="3737924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223842" y="1267795"/>
            <a:ext cx="42049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3h. 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865953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77</Words>
  <Application>Microsoft Office PowerPoint</Application>
  <PresentationFormat>全屏显示(4:3)</PresentationFormat>
  <Paragraphs>38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11</cp:revision>
  <dcterms:created xsi:type="dcterms:W3CDTF">2020-08-31T12:05:01Z</dcterms:created>
  <dcterms:modified xsi:type="dcterms:W3CDTF">2020-10-12T07:50:03Z</dcterms:modified>
</cp:coreProperties>
</file>